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C3E06A-F459-47F7-B700-EF58CDBB06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CE0175-129C-4A25-97AD-0CEE924C51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F8EF9-1D8A-4FED-A726-F672359B5A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E180DD-9C11-45C3-89C0-50A08E43EF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FAC458-DDFD-45EA-8555-14146A2BC8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F3452-A1CA-4531-B182-44AFB57399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7A60C8-7454-404F-B4E7-EB029CB6DE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E9EE50-15CE-42A1-94CF-0CD1DA25E4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DF56EF-4461-4828-8535-F47E815AFF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4BD612-87DC-4E4D-9C7C-55DAE42517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ADE9B-720B-4AB5-AF53-4C68AF8F26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DEA49D-4A14-47D2-B20F-D3D5B711EB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D0ACFC-1461-47B6-9080-0C169E91926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81000" y="2505240"/>
          <a:ext cx="5040360" cy="920520"/>
        </p:xfrm>
        <a:graphic>
          <a:graphicData uri="http://schemas.openxmlformats.org/drawingml/2006/table">
            <a:tbl>
              <a:tblPr/>
              <a:tblGrid>
                <a:gridCol w="1333440"/>
                <a:gridCol w="890640"/>
                <a:gridCol w="962280"/>
                <a:gridCol w="965160"/>
                <a:gridCol w="888840"/>
              </a:tblGrid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No antige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Pf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PP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PH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4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City naiv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2.7 ± 1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13.8 ± 8.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9.3 ± 11.31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79.2 ± 7.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Rural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4.1 ± 4.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17.8 ± 19.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17.4 ± 19.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84.1 ± 14.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Rural 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5.2 ± 5.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17.8± 12.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20.8 ± 17.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77.1 ± 17.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 Box 42"/>
          <p:cNvSpPr/>
          <p:nvPr/>
        </p:nvSpPr>
        <p:spPr>
          <a:xfrm>
            <a:off x="1143000" y="2038320"/>
            <a:ext cx="4811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upplementary Table S1.</a:t>
            </a:r>
            <a:r>
              <a:rPr b="1" lang="th-TH" sz="1000" spc="-1" strike="noStrike">
                <a:solidFill>
                  <a:srgbClr val="000000"/>
                </a:solidFill>
                <a:latin typeface="Calibri"/>
                <a:ea typeface="Cordia New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The mean ± SD of the percentages of CD45RO+ CD4+ T cells that divided (i.e. were CFS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low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) after in vitro restimulation with PfSE, PPD or PHA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30"/>
          <p:cNvSpPr/>
          <p:nvPr/>
        </p:nvSpPr>
        <p:spPr>
          <a:xfrm>
            <a:off x="0" y="160020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27T09:16:49Z</dcterms:created>
  <dc:creator>Tay</dc:creator>
  <dc:description/>
  <dc:language>en-US</dc:language>
  <cp:lastModifiedBy>IIMMERIL</cp:lastModifiedBy>
  <dcterms:modified xsi:type="dcterms:W3CDTF">2011-01-04T13:53:04Z</dcterms:modified>
  <cp:revision>31</cp:revision>
  <dc:subject/>
  <dc:title>Slide 1</dc:title>
</cp:coreProperties>
</file>